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08"/>
    <p:restoredTop sz="94618"/>
  </p:normalViewPr>
  <p:slideViewPr>
    <p:cSldViewPr snapToGrid="0" snapToObjects="1">
      <p:cViewPr varScale="1">
        <p:scale>
          <a:sx n="82" d="100"/>
          <a:sy n="82" d="100"/>
        </p:scale>
        <p:origin x="1160" y="1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D2BCE65-8CF0-A14B-8F41-1B9C6B1BFAC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90C47D43-8BA5-5148-BBA9-E2FF27B7775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F4C0D44-47B9-8C4D-B025-66C841F9CE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CFE56-E89A-074C-8356-6DFA6552D3BA}" type="datetimeFigureOut">
              <a:rPr lang="fr-FR" smtClean="0"/>
              <a:t>12/09/2018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B22D818-557F-4242-B006-9619F4A029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08873F5-D964-CF49-B11D-62D7C362CD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7A7FBF-EA3C-384C-AD56-27FA221A15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268505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9D0787F-9F8A-B844-BCA9-ACE15145EA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05ED8596-63D3-8740-9929-A41CE23C82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42D3190-1D5E-7544-8B93-B0858979D1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CFE56-E89A-074C-8356-6DFA6552D3BA}" type="datetimeFigureOut">
              <a:rPr lang="fr-FR" smtClean="0"/>
              <a:t>12/09/2018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FDD8D07-0446-1D49-9D32-B5D923D4B6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D9C3E51-2C05-F548-895A-95E405557D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7A7FBF-EA3C-384C-AD56-27FA221A15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557997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197B27B7-8782-7443-9C13-47B6214C98F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D5E2AA4D-3B72-004B-914B-48A23B1641F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2D57697-0984-B446-A074-B649390449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CFE56-E89A-074C-8356-6DFA6552D3BA}" type="datetimeFigureOut">
              <a:rPr lang="fr-FR" smtClean="0"/>
              <a:t>12/09/2018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345B6D7-AC41-2841-AB51-E579B6E227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C6862F6-CFE1-464E-8B4D-350419ABE9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7A7FBF-EA3C-384C-AD56-27FA221A15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027248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8534999-DFA8-5644-92D0-1BFB1DA87D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F9B80D6-7623-E143-A924-CB9836DFACC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8F6E77A-0771-2C40-B7B6-F9C7B1A0D1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CFE56-E89A-074C-8356-6DFA6552D3BA}" type="datetimeFigureOut">
              <a:rPr lang="fr-FR" smtClean="0"/>
              <a:t>12/09/2018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B7B1527-C5CF-9046-84C2-97ABC673EA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91D0DC1-C081-8B42-A99E-39C2A27869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7A7FBF-EA3C-384C-AD56-27FA221A15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749277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4B429BB-1699-E345-86C6-8EEF980DEF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060513D-4AF5-174C-AB28-E948A49AF4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0606A60-957A-594D-BDB8-912876A069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CFE56-E89A-074C-8356-6DFA6552D3BA}" type="datetimeFigureOut">
              <a:rPr lang="fr-FR" smtClean="0"/>
              <a:t>12/09/2018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E32C7FB-F2A1-CA49-BC12-0E73A242B9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A4DAF10-2DA8-F946-8FDB-AF0797F0A3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7A7FBF-EA3C-384C-AD56-27FA221A15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973466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5DF049E-4303-8247-B580-063DA16EA0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B37DB064-E7E5-9F49-B75D-3C8A6C4C88C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CA5B735C-D932-B148-89AF-FA4F23FE1C8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FAD550A0-DCE5-D845-A3D0-7596A3D51A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CFE56-E89A-074C-8356-6DFA6552D3BA}" type="datetimeFigureOut">
              <a:rPr lang="fr-FR" smtClean="0"/>
              <a:t>12/09/2018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A98AC5B1-A24A-3B46-B2E9-26A93403F4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9A1F32B7-7530-3A41-84E2-85F3B049B3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7A7FBF-EA3C-384C-AD56-27FA221A15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792865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4710B85-F3DA-1B46-A1E1-28C4319EA7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75A28EB9-7CB4-D840-A440-CAD160E335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E29998DA-213E-8446-BFD1-8F99B65FD64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4447F471-5136-1B44-976D-14083C51342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400681E2-CF9E-684D-8041-01FC57C034A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38CD116D-756B-944C-9831-4269061514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CFE56-E89A-074C-8356-6DFA6552D3BA}" type="datetimeFigureOut">
              <a:rPr lang="fr-FR" smtClean="0"/>
              <a:t>12/09/2018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E29C240E-73BF-4043-8F48-D9B91D91C0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4C404C64-2D91-084E-AC7B-3B9038A3A7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7A7FBF-EA3C-384C-AD56-27FA221A15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688245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BBA6334-8EC8-B24B-ABAF-A5E5A92475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84D156E4-AB63-DF4E-9D9A-D6542D426F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CFE56-E89A-074C-8356-6DFA6552D3BA}" type="datetimeFigureOut">
              <a:rPr lang="fr-FR" smtClean="0"/>
              <a:t>12/09/2018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5391FA61-692E-A94D-AE96-A32CE337D0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97B61707-9C19-A644-AFBC-16C52C1799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7A7FBF-EA3C-384C-AD56-27FA221A15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313061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BCEC3640-8D2B-E244-B3C0-6E97684D01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CFE56-E89A-074C-8356-6DFA6552D3BA}" type="datetimeFigureOut">
              <a:rPr lang="fr-FR" smtClean="0"/>
              <a:t>12/09/2018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C3F4BF7A-1AE9-E748-B2D7-63BD9E9A89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76E39A2C-AC60-9E43-B8CD-7906226B0E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7A7FBF-EA3C-384C-AD56-27FA221A15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380090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7F9FACC-3EBB-D648-8795-0577965BFA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5E8A510-A0F8-114C-930C-043C46213CB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67C4B7C0-AE84-034A-AC17-166801FEEDD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020A58F7-AC3C-0542-B26F-4DC9D92048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CFE56-E89A-074C-8356-6DFA6552D3BA}" type="datetimeFigureOut">
              <a:rPr lang="fr-FR" smtClean="0"/>
              <a:t>12/09/2018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6826F70B-9CE5-C147-A41B-A66C5900F8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D6009341-3A9B-304B-9777-CCEECD2EF6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7A7FBF-EA3C-384C-AD56-27FA221A15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273651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C1683EB-3ECE-B94B-AFF8-0706F8C1B7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0E7AC06C-19DA-054E-B722-7FA15C15B91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117EB5D4-D05E-7F4C-9C1D-5F37BC555DC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73472123-8BC3-9C48-B040-EB747005FD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CFE56-E89A-074C-8356-6DFA6552D3BA}" type="datetimeFigureOut">
              <a:rPr lang="fr-FR" smtClean="0"/>
              <a:t>12/09/2018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2809B51-50F8-8A48-8854-3C1CF4F8C4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258DD03-F876-6249-8B4A-0A9DE628B4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7A7FBF-EA3C-384C-AD56-27FA221A15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772450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CD64E59F-6A32-7643-8E2E-687AB50404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7EC7F138-1127-E347-B717-627D67BBA6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3B5E4F3-A7F6-F748-A429-14758D1FA40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ACFE56-E89A-074C-8356-6DFA6552D3BA}" type="datetimeFigureOut">
              <a:rPr lang="fr-FR" smtClean="0"/>
              <a:t>12/09/2018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2FB0718-43D7-E54F-847B-2FF37186DB3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3E48DF1-9460-1E4A-BB66-ECD41823299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7A7FBF-EA3C-384C-AD56-27FA221A15F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021448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Image 7">
            <a:extLst>
              <a:ext uri="{FF2B5EF4-FFF2-40B4-BE49-F238E27FC236}">
                <a16:creationId xmlns:a16="http://schemas.microsoft.com/office/drawing/2014/main" id="{8EE05C90-4C6E-D14A-84C8-7D99B46752C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4535" y="0"/>
            <a:ext cx="4349626" cy="6858000"/>
          </a:xfrm>
          <a:prstGeom prst="rect">
            <a:avLst/>
          </a:prstGeom>
        </p:spPr>
      </p:pic>
      <p:sp>
        <p:nvSpPr>
          <p:cNvPr id="10" name="ZoneTexte 9">
            <a:extLst>
              <a:ext uri="{FF2B5EF4-FFF2-40B4-BE49-F238E27FC236}">
                <a16:creationId xmlns:a16="http://schemas.microsoft.com/office/drawing/2014/main" id="{EA3DB5D4-8B36-F44C-974B-32E88C6343BF}"/>
              </a:ext>
            </a:extLst>
          </p:cNvPr>
          <p:cNvSpPr txBox="1"/>
          <p:nvPr/>
        </p:nvSpPr>
        <p:spPr>
          <a:xfrm>
            <a:off x="5625049" y="6214820"/>
            <a:ext cx="12398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SiOrai-1</a:t>
            </a:r>
          </a:p>
        </p:txBody>
      </p:sp>
      <p:grpSp>
        <p:nvGrpSpPr>
          <p:cNvPr id="17" name="Groupe 16">
            <a:extLst>
              <a:ext uri="{FF2B5EF4-FFF2-40B4-BE49-F238E27FC236}">
                <a16:creationId xmlns:a16="http://schemas.microsoft.com/office/drawing/2014/main" id="{AB64C60D-2400-AC48-93CE-6032031681DA}"/>
              </a:ext>
            </a:extLst>
          </p:cNvPr>
          <p:cNvGrpSpPr/>
          <p:nvPr/>
        </p:nvGrpSpPr>
        <p:grpSpPr>
          <a:xfrm>
            <a:off x="7098225" y="2061275"/>
            <a:ext cx="3099660" cy="1689316"/>
            <a:chOff x="7098225" y="2061275"/>
            <a:chExt cx="3099660" cy="1689316"/>
          </a:xfrm>
        </p:grpSpPr>
        <p:pic>
          <p:nvPicPr>
            <p:cNvPr id="9" name="Image 8">
              <a:extLst>
                <a:ext uri="{FF2B5EF4-FFF2-40B4-BE49-F238E27FC236}">
                  <a16:creationId xmlns:a16="http://schemas.microsoft.com/office/drawing/2014/main" id="{8E024962-0A6F-134D-BE66-7E1F05EEAAC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28168" t="37740" r="23373" b="45311"/>
            <a:stretch/>
          </p:blipFill>
          <p:spPr>
            <a:xfrm>
              <a:off x="8090114" y="2588217"/>
              <a:ext cx="2107771" cy="1162374"/>
            </a:xfrm>
            <a:prstGeom prst="rect">
              <a:avLst/>
            </a:prstGeom>
          </p:spPr>
        </p:pic>
        <p:grpSp>
          <p:nvGrpSpPr>
            <p:cNvPr id="14" name="Groupe 13">
              <a:extLst>
                <a:ext uri="{FF2B5EF4-FFF2-40B4-BE49-F238E27FC236}">
                  <a16:creationId xmlns:a16="http://schemas.microsoft.com/office/drawing/2014/main" id="{1A3E160F-7B4E-4048-AD27-005F196A5994}"/>
                </a:ext>
              </a:extLst>
            </p:cNvPr>
            <p:cNvGrpSpPr/>
            <p:nvPr/>
          </p:nvGrpSpPr>
          <p:grpSpPr>
            <a:xfrm>
              <a:off x="7098225" y="2807818"/>
              <a:ext cx="1069383" cy="369332"/>
              <a:chOff x="7160217" y="2699332"/>
              <a:chExt cx="1069383" cy="369332"/>
            </a:xfrm>
          </p:grpSpPr>
          <p:cxnSp>
            <p:nvCxnSpPr>
              <p:cNvPr id="12" name="Connecteur droit 11">
                <a:extLst>
                  <a:ext uri="{FF2B5EF4-FFF2-40B4-BE49-F238E27FC236}">
                    <a16:creationId xmlns:a16="http://schemas.microsoft.com/office/drawing/2014/main" id="{8BC8A49A-C11E-A74C-8DED-934FDF9CC0FE}"/>
                  </a:ext>
                </a:extLst>
              </p:cNvPr>
              <p:cNvCxnSpPr/>
              <p:nvPr/>
            </p:nvCxnSpPr>
            <p:spPr>
              <a:xfrm>
                <a:off x="7935132" y="2991173"/>
                <a:ext cx="29446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" name="ZoneTexte 12">
                <a:extLst>
                  <a:ext uri="{FF2B5EF4-FFF2-40B4-BE49-F238E27FC236}">
                    <a16:creationId xmlns:a16="http://schemas.microsoft.com/office/drawing/2014/main" id="{69FAF5AE-5DAA-A142-8E78-DD0BE6EE4215}"/>
                  </a:ext>
                </a:extLst>
              </p:cNvPr>
              <p:cNvSpPr txBox="1"/>
              <p:nvPr/>
            </p:nvSpPr>
            <p:spPr>
              <a:xfrm>
                <a:off x="7160217" y="2699332"/>
                <a:ext cx="85240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dirty="0"/>
                  <a:t>75 KDa</a:t>
                </a:r>
              </a:p>
            </p:txBody>
          </p:sp>
        </p:grpSp>
        <p:sp>
          <p:nvSpPr>
            <p:cNvPr id="15" name="ZoneTexte 14">
              <a:extLst>
                <a:ext uri="{FF2B5EF4-FFF2-40B4-BE49-F238E27FC236}">
                  <a16:creationId xmlns:a16="http://schemas.microsoft.com/office/drawing/2014/main" id="{9D6441AD-3DB1-DF49-85C6-064C9DC65E18}"/>
                </a:ext>
              </a:extLst>
            </p:cNvPr>
            <p:cNvSpPr txBox="1"/>
            <p:nvPr/>
          </p:nvSpPr>
          <p:spPr>
            <a:xfrm>
              <a:off x="8229599" y="2061275"/>
              <a:ext cx="105388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dirty="0"/>
                <a:t>Si-Orai-1</a:t>
              </a:r>
            </a:p>
          </p:txBody>
        </p:sp>
        <p:sp>
          <p:nvSpPr>
            <p:cNvPr id="16" name="ZoneTexte 15">
              <a:extLst>
                <a:ext uri="{FF2B5EF4-FFF2-40B4-BE49-F238E27FC236}">
                  <a16:creationId xmlns:a16="http://schemas.microsoft.com/office/drawing/2014/main" id="{F5FD12FC-1871-174A-B0EC-05E2FE61B2F0}"/>
                </a:ext>
              </a:extLst>
            </p:cNvPr>
            <p:cNvSpPr txBox="1"/>
            <p:nvPr/>
          </p:nvSpPr>
          <p:spPr>
            <a:xfrm>
              <a:off x="9283484" y="2061275"/>
              <a:ext cx="83690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dirty="0"/>
                <a:t>Si-Ctrl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8816440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36833FC6-A8E2-BE4B-87CB-9290A62BC02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80897" y="0"/>
            <a:ext cx="3847563" cy="6780321"/>
          </a:xfrm>
          <a:prstGeom prst="rect">
            <a:avLst/>
          </a:prstGeom>
        </p:spPr>
      </p:pic>
      <p:grpSp>
        <p:nvGrpSpPr>
          <p:cNvPr id="14" name="Groupe 13">
            <a:extLst>
              <a:ext uri="{FF2B5EF4-FFF2-40B4-BE49-F238E27FC236}">
                <a16:creationId xmlns:a16="http://schemas.microsoft.com/office/drawing/2014/main" id="{E09764FB-479E-BD44-9DBB-8BBD7808D179}"/>
              </a:ext>
            </a:extLst>
          </p:cNvPr>
          <p:cNvGrpSpPr/>
          <p:nvPr/>
        </p:nvGrpSpPr>
        <p:grpSpPr>
          <a:xfrm>
            <a:off x="6106333" y="2327371"/>
            <a:ext cx="3017899" cy="1057110"/>
            <a:chOff x="6106333" y="2327371"/>
            <a:chExt cx="3017899" cy="1057110"/>
          </a:xfrm>
        </p:grpSpPr>
        <p:pic>
          <p:nvPicPr>
            <p:cNvPr id="6" name="Image 5">
              <a:extLst>
                <a:ext uri="{FF2B5EF4-FFF2-40B4-BE49-F238E27FC236}">
                  <a16:creationId xmlns:a16="http://schemas.microsoft.com/office/drawing/2014/main" id="{0660D111-D0FD-F646-B042-EA0CE6198C4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21923" t="41830" r="24907" b="50246"/>
            <a:stretch/>
          </p:blipFill>
          <p:spPr>
            <a:xfrm>
              <a:off x="7036232" y="2836189"/>
              <a:ext cx="2088000" cy="548292"/>
            </a:xfrm>
            <a:prstGeom prst="rect">
              <a:avLst/>
            </a:prstGeom>
          </p:spPr>
        </p:pic>
        <p:cxnSp>
          <p:nvCxnSpPr>
            <p:cNvPr id="7" name="Connecteur droit 6">
              <a:extLst>
                <a:ext uri="{FF2B5EF4-FFF2-40B4-BE49-F238E27FC236}">
                  <a16:creationId xmlns:a16="http://schemas.microsoft.com/office/drawing/2014/main" id="{AA72378C-E41B-374C-9D1C-9DB03FE3143E}"/>
                </a:ext>
              </a:extLst>
            </p:cNvPr>
            <p:cNvCxnSpPr/>
            <p:nvPr/>
          </p:nvCxnSpPr>
          <p:spPr>
            <a:xfrm>
              <a:off x="6881248" y="3146155"/>
              <a:ext cx="294468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ZoneTexte 7">
              <a:extLst>
                <a:ext uri="{FF2B5EF4-FFF2-40B4-BE49-F238E27FC236}">
                  <a16:creationId xmlns:a16="http://schemas.microsoft.com/office/drawing/2014/main" id="{EDA57332-2E11-CF49-A5A5-6CCA4771AE71}"/>
                </a:ext>
              </a:extLst>
            </p:cNvPr>
            <p:cNvSpPr txBox="1"/>
            <p:nvPr/>
          </p:nvSpPr>
          <p:spPr>
            <a:xfrm>
              <a:off x="6106333" y="2854314"/>
              <a:ext cx="8524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dirty="0"/>
                <a:t>75 KDa</a:t>
              </a:r>
            </a:p>
          </p:txBody>
        </p:sp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id="{9B97022E-9C0B-B340-8292-D77192E6D55D}"/>
                </a:ext>
              </a:extLst>
            </p:cNvPr>
            <p:cNvSpPr txBox="1"/>
            <p:nvPr/>
          </p:nvSpPr>
          <p:spPr>
            <a:xfrm>
              <a:off x="7067227" y="2327371"/>
              <a:ext cx="117787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dirty="0"/>
                <a:t>Si-STIM-1</a:t>
              </a:r>
            </a:p>
          </p:txBody>
        </p:sp>
        <p:sp>
          <p:nvSpPr>
            <p:cNvPr id="10" name="ZoneTexte 9">
              <a:extLst>
                <a:ext uri="{FF2B5EF4-FFF2-40B4-BE49-F238E27FC236}">
                  <a16:creationId xmlns:a16="http://schemas.microsoft.com/office/drawing/2014/main" id="{B2CDB032-C12A-C14A-9FB2-55E11C1E4F7B}"/>
                </a:ext>
              </a:extLst>
            </p:cNvPr>
            <p:cNvSpPr txBox="1"/>
            <p:nvPr/>
          </p:nvSpPr>
          <p:spPr>
            <a:xfrm>
              <a:off x="8245098" y="2329999"/>
              <a:ext cx="83690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dirty="0"/>
                <a:t>Si-Ctrl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4470076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oupe 21">
            <a:extLst>
              <a:ext uri="{FF2B5EF4-FFF2-40B4-BE49-F238E27FC236}">
                <a16:creationId xmlns:a16="http://schemas.microsoft.com/office/drawing/2014/main" id="{91A66AAE-CABE-134E-8B1C-4E11F8456513}"/>
              </a:ext>
            </a:extLst>
          </p:cNvPr>
          <p:cNvGrpSpPr/>
          <p:nvPr/>
        </p:nvGrpSpPr>
        <p:grpSpPr>
          <a:xfrm>
            <a:off x="2816608" y="818589"/>
            <a:ext cx="3315904" cy="3009901"/>
            <a:chOff x="6881981" y="1955410"/>
            <a:chExt cx="3315904" cy="3009901"/>
          </a:xfrm>
        </p:grpSpPr>
        <p:grpSp>
          <p:nvGrpSpPr>
            <p:cNvPr id="2" name="Groupe 1">
              <a:extLst>
                <a:ext uri="{FF2B5EF4-FFF2-40B4-BE49-F238E27FC236}">
                  <a16:creationId xmlns:a16="http://schemas.microsoft.com/office/drawing/2014/main" id="{F66C0FEA-4EEC-764F-A2D2-46A93478224F}"/>
                </a:ext>
              </a:extLst>
            </p:cNvPr>
            <p:cNvGrpSpPr/>
            <p:nvPr/>
          </p:nvGrpSpPr>
          <p:grpSpPr>
            <a:xfrm>
              <a:off x="7098225" y="2061275"/>
              <a:ext cx="3099660" cy="1689316"/>
              <a:chOff x="7098225" y="2061275"/>
              <a:chExt cx="3099660" cy="1689316"/>
            </a:xfrm>
          </p:grpSpPr>
          <p:pic>
            <p:nvPicPr>
              <p:cNvPr id="3" name="Image 2">
                <a:extLst>
                  <a:ext uri="{FF2B5EF4-FFF2-40B4-BE49-F238E27FC236}">
                    <a16:creationId xmlns:a16="http://schemas.microsoft.com/office/drawing/2014/main" id="{3F52BD2C-6E3F-5C46-B99D-9B12881A193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28168" t="37740" r="23373" b="45311"/>
              <a:stretch/>
            </p:blipFill>
            <p:spPr>
              <a:xfrm>
                <a:off x="8090114" y="2588217"/>
                <a:ext cx="2107771" cy="1162374"/>
              </a:xfrm>
              <a:prstGeom prst="rect">
                <a:avLst/>
              </a:prstGeom>
            </p:spPr>
          </p:pic>
          <p:grpSp>
            <p:nvGrpSpPr>
              <p:cNvPr id="4" name="Groupe 3">
                <a:extLst>
                  <a:ext uri="{FF2B5EF4-FFF2-40B4-BE49-F238E27FC236}">
                    <a16:creationId xmlns:a16="http://schemas.microsoft.com/office/drawing/2014/main" id="{37399F5C-CD2C-8148-925B-C9A3DC133183}"/>
                  </a:ext>
                </a:extLst>
              </p:cNvPr>
              <p:cNvGrpSpPr/>
              <p:nvPr/>
            </p:nvGrpSpPr>
            <p:grpSpPr>
              <a:xfrm>
                <a:off x="7098225" y="2807818"/>
                <a:ext cx="1069383" cy="369332"/>
                <a:chOff x="7160217" y="2699332"/>
                <a:chExt cx="1069383" cy="369332"/>
              </a:xfrm>
            </p:grpSpPr>
            <p:cxnSp>
              <p:nvCxnSpPr>
                <p:cNvPr id="7" name="Connecteur droit 6">
                  <a:extLst>
                    <a:ext uri="{FF2B5EF4-FFF2-40B4-BE49-F238E27FC236}">
                      <a16:creationId xmlns:a16="http://schemas.microsoft.com/office/drawing/2014/main" id="{EEF4E165-45EC-9B40-AB3C-173BB774F5DB}"/>
                    </a:ext>
                  </a:extLst>
                </p:cNvPr>
                <p:cNvCxnSpPr/>
                <p:nvPr/>
              </p:nvCxnSpPr>
              <p:spPr>
                <a:xfrm>
                  <a:off x="7935132" y="2991173"/>
                  <a:ext cx="294468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" name="ZoneTexte 7">
                  <a:extLst>
                    <a:ext uri="{FF2B5EF4-FFF2-40B4-BE49-F238E27FC236}">
                      <a16:creationId xmlns:a16="http://schemas.microsoft.com/office/drawing/2014/main" id="{9FAC4D2B-B69C-D046-BC48-247C7FE06E5E}"/>
                    </a:ext>
                  </a:extLst>
                </p:cNvPr>
                <p:cNvSpPr txBox="1"/>
                <p:nvPr/>
              </p:nvSpPr>
              <p:spPr>
                <a:xfrm>
                  <a:off x="7160217" y="2699332"/>
                  <a:ext cx="852406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dirty="0"/>
                    <a:t>75 KDa</a:t>
                  </a:r>
                </a:p>
              </p:txBody>
            </p:sp>
          </p:grpSp>
          <p:sp>
            <p:nvSpPr>
              <p:cNvPr id="5" name="ZoneTexte 4">
                <a:extLst>
                  <a:ext uri="{FF2B5EF4-FFF2-40B4-BE49-F238E27FC236}">
                    <a16:creationId xmlns:a16="http://schemas.microsoft.com/office/drawing/2014/main" id="{33EAF861-1931-4A4A-B6D5-CB6ADA1951D2}"/>
                  </a:ext>
                </a:extLst>
              </p:cNvPr>
              <p:cNvSpPr txBox="1"/>
              <p:nvPr/>
            </p:nvSpPr>
            <p:spPr>
              <a:xfrm>
                <a:off x="8229599" y="2061275"/>
                <a:ext cx="105388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dirty="0"/>
                  <a:t>Si-Orai-1</a:t>
                </a:r>
              </a:p>
            </p:txBody>
          </p:sp>
          <p:sp>
            <p:nvSpPr>
              <p:cNvPr id="6" name="ZoneTexte 5">
                <a:extLst>
                  <a:ext uri="{FF2B5EF4-FFF2-40B4-BE49-F238E27FC236}">
                    <a16:creationId xmlns:a16="http://schemas.microsoft.com/office/drawing/2014/main" id="{D20B16ED-009F-9B47-8FD9-BAAD14567E28}"/>
                  </a:ext>
                </a:extLst>
              </p:cNvPr>
              <p:cNvSpPr txBox="1"/>
              <p:nvPr/>
            </p:nvSpPr>
            <p:spPr>
              <a:xfrm>
                <a:off x="9283484" y="2061275"/>
                <a:ext cx="83690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dirty="0"/>
                  <a:t>Si-Ctrl</a:t>
                </a:r>
              </a:p>
            </p:txBody>
          </p:sp>
        </p:grpSp>
        <p:grpSp>
          <p:nvGrpSpPr>
            <p:cNvPr id="15" name="Groupe 14">
              <a:extLst>
                <a:ext uri="{FF2B5EF4-FFF2-40B4-BE49-F238E27FC236}">
                  <a16:creationId xmlns:a16="http://schemas.microsoft.com/office/drawing/2014/main" id="{0DABB0C1-086B-D340-A2D3-94B467915E6B}"/>
                </a:ext>
              </a:extLst>
            </p:cNvPr>
            <p:cNvGrpSpPr/>
            <p:nvPr/>
          </p:nvGrpSpPr>
          <p:grpSpPr>
            <a:xfrm>
              <a:off x="7179986" y="3908201"/>
              <a:ext cx="3017899" cy="1057110"/>
              <a:chOff x="6106333" y="2327371"/>
              <a:chExt cx="3017899" cy="1057110"/>
            </a:xfrm>
          </p:grpSpPr>
          <p:pic>
            <p:nvPicPr>
              <p:cNvPr id="16" name="Image 15">
                <a:extLst>
                  <a:ext uri="{FF2B5EF4-FFF2-40B4-BE49-F238E27FC236}">
                    <a16:creationId xmlns:a16="http://schemas.microsoft.com/office/drawing/2014/main" id="{9A0AC185-A676-A342-B2B8-995031432D9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21923" t="41830" r="24907" b="50246"/>
              <a:stretch/>
            </p:blipFill>
            <p:spPr>
              <a:xfrm>
                <a:off x="7036232" y="2836189"/>
                <a:ext cx="2088000" cy="548292"/>
              </a:xfrm>
              <a:prstGeom prst="rect">
                <a:avLst/>
              </a:prstGeom>
            </p:spPr>
          </p:pic>
          <p:cxnSp>
            <p:nvCxnSpPr>
              <p:cNvPr id="17" name="Connecteur droit 16">
                <a:extLst>
                  <a:ext uri="{FF2B5EF4-FFF2-40B4-BE49-F238E27FC236}">
                    <a16:creationId xmlns:a16="http://schemas.microsoft.com/office/drawing/2014/main" id="{6609EC80-D01A-F149-9576-168375FDC96C}"/>
                  </a:ext>
                </a:extLst>
              </p:cNvPr>
              <p:cNvCxnSpPr/>
              <p:nvPr/>
            </p:nvCxnSpPr>
            <p:spPr>
              <a:xfrm>
                <a:off x="6881248" y="3146155"/>
                <a:ext cx="29446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" name="ZoneTexte 17">
                <a:extLst>
                  <a:ext uri="{FF2B5EF4-FFF2-40B4-BE49-F238E27FC236}">
                    <a16:creationId xmlns:a16="http://schemas.microsoft.com/office/drawing/2014/main" id="{FE663A9E-E4E6-7C48-8F52-664D866FB44B}"/>
                  </a:ext>
                </a:extLst>
              </p:cNvPr>
              <p:cNvSpPr txBox="1"/>
              <p:nvPr/>
            </p:nvSpPr>
            <p:spPr>
              <a:xfrm>
                <a:off x="6106333" y="2854314"/>
                <a:ext cx="85240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dirty="0"/>
                  <a:t>75 KDa</a:t>
                </a:r>
              </a:p>
            </p:txBody>
          </p:sp>
          <p:sp>
            <p:nvSpPr>
              <p:cNvPr id="19" name="ZoneTexte 18">
                <a:extLst>
                  <a:ext uri="{FF2B5EF4-FFF2-40B4-BE49-F238E27FC236}">
                    <a16:creationId xmlns:a16="http://schemas.microsoft.com/office/drawing/2014/main" id="{522D9606-752B-4548-99FE-965630F9343F}"/>
                  </a:ext>
                </a:extLst>
              </p:cNvPr>
              <p:cNvSpPr txBox="1"/>
              <p:nvPr/>
            </p:nvSpPr>
            <p:spPr>
              <a:xfrm>
                <a:off x="7067227" y="2327371"/>
                <a:ext cx="117787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dirty="0"/>
                  <a:t>Si-STIM-1</a:t>
                </a:r>
              </a:p>
            </p:txBody>
          </p:sp>
          <p:sp>
            <p:nvSpPr>
              <p:cNvPr id="20" name="ZoneTexte 19">
                <a:extLst>
                  <a:ext uri="{FF2B5EF4-FFF2-40B4-BE49-F238E27FC236}">
                    <a16:creationId xmlns:a16="http://schemas.microsoft.com/office/drawing/2014/main" id="{8D1D0522-CDAB-444E-BF46-1CDFA2E85C4C}"/>
                  </a:ext>
                </a:extLst>
              </p:cNvPr>
              <p:cNvSpPr txBox="1"/>
              <p:nvPr/>
            </p:nvSpPr>
            <p:spPr>
              <a:xfrm>
                <a:off x="8245098" y="2329999"/>
                <a:ext cx="83690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dirty="0"/>
                  <a:t>Si-Ctrl</a:t>
                </a:r>
              </a:p>
            </p:txBody>
          </p:sp>
        </p:grpSp>
        <p:sp>
          <p:nvSpPr>
            <p:cNvPr id="21" name="ZoneTexte 20">
              <a:extLst>
                <a:ext uri="{FF2B5EF4-FFF2-40B4-BE49-F238E27FC236}">
                  <a16:creationId xmlns:a16="http://schemas.microsoft.com/office/drawing/2014/main" id="{27C1B1A5-6325-A54B-9357-32D5F6E3246A}"/>
                </a:ext>
              </a:extLst>
            </p:cNvPr>
            <p:cNvSpPr txBox="1"/>
            <p:nvPr/>
          </p:nvSpPr>
          <p:spPr>
            <a:xfrm>
              <a:off x="6881981" y="1955410"/>
              <a:ext cx="43248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600" b="1" dirty="0">
                  <a:latin typeface="Geneva" panose="020B0503030404040204" pitchFamily="34" charset="0"/>
                  <a:ea typeface="Geneva" panose="020B0503030404040204" pitchFamily="34" charset="0"/>
                </a:rPr>
                <a:t>C</a:t>
              </a:r>
            </a:p>
          </p:txBody>
        </p:sp>
      </p:grpSp>
      <p:sp>
        <p:nvSpPr>
          <p:cNvPr id="23" name="ZoneTexte 22">
            <a:extLst>
              <a:ext uri="{FF2B5EF4-FFF2-40B4-BE49-F238E27FC236}">
                <a16:creationId xmlns:a16="http://schemas.microsoft.com/office/drawing/2014/main" id="{A8086D9C-8C6F-F646-B122-016F96B2A1B3}"/>
              </a:ext>
            </a:extLst>
          </p:cNvPr>
          <p:cNvSpPr txBox="1"/>
          <p:nvPr/>
        </p:nvSpPr>
        <p:spPr>
          <a:xfrm>
            <a:off x="4373455" y="4494918"/>
            <a:ext cx="12631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Figure 6C</a:t>
            </a: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287A3678-7989-4441-8CE9-53967CFD9CC4}"/>
              </a:ext>
            </a:extLst>
          </p:cNvPr>
          <p:cNvSpPr txBox="1"/>
          <p:nvPr/>
        </p:nvSpPr>
        <p:spPr>
          <a:xfrm>
            <a:off x="7858897" y="1157143"/>
            <a:ext cx="376881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err="1"/>
              <a:t>Autoradio</a:t>
            </a:r>
            <a:r>
              <a:rPr lang="en-GB" dirty="0"/>
              <a:t> films of respective Western blots have been scanned on 600dpi and saved in </a:t>
            </a:r>
            <a:r>
              <a:rPr lang="en-GB" dirty="0" err="1"/>
              <a:t>png</a:t>
            </a:r>
            <a:r>
              <a:rPr lang="en-GB" dirty="0"/>
              <a:t> file. These files have been uploaded in power point files</a:t>
            </a:r>
          </a:p>
        </p:txBody>
      </p:sp>
    </p:spTree>
    <p:extLst>
      <p:ext uri="{BB962C8B-B14F-4D97-AF65-F5344CB8AC3E}">
        <p14:creationId xmlns:p14="http://schemas.microsoft.com/office/powerpoint/2010/main" val="276213969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46</Words>
  <Application>Microsoft Macintosh PowerPoint</Application>
  <PresentationFormat>Grand écran</PresentationFormat>
  <Paragraphs>16</Paragraphs>
  <Slides>3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Geneva</vt:lpstr>
      <vt:lpstr>Thème Office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rosoft Office User</dc:creator>
  <cp:lastModifiedBy>Microsoft Office User</cp:lastModifiedBy>
  <cp:revision>7</cp:revision>
  <dcterms:created xsi:type="dcterms:W3CDTF">2018-09-11T09:31:37Z</dcterms:created>
  <dcterms:modified xsi:type="dcterms:W3CDTF">2018-09-12T08:40:08Z</dcterms:modified>
</cp:coreProperties>
</file>